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s-C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E12C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 varScale="1">
        <p:scale>
          <a:sx n="91" d="100"/>
          <a:sy n="91" d="100"/>
        </p:scale>
        <p:origin x="53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CO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CO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E7827-6388-4C4B-8BD5-6288164DBA47}" type="datetimeFigureOut">
              <a:rPr lang="es-CO" smtClean="0"/>
              <a:t>15/08/2017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F33220-DD61-43B1-8220-FA43930A12B3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221438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O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E7827-6388-4C4B-8BD5-6288164DBA47}" type="datetimeFigureOut">
              <a:rPr lang="es-CO" smtClean="0"/>
              <a:t>15/08/2017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F33220-DD61-43B1-8220-FA43930A12B3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515602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O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E7827-6388-4C4B-8BD5-6288164DBA47}" type="datetimeFigureOut">
              <a:rPr lang="es-CO" smtClean="0"/>
              <a:t>15/08/2017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F33220-DD61-43B1-8220-FA43930A12B3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7149814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O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E7827-6388-4C4B-8BD5-6288164DBA47}" type="datetimeFigureOut">
              <a:rPr lang="es-CO" smtClean="0"/>
              <a:t>15/08/2017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F33220-DD61-43B1-8220-FA43930A12B3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0064419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E7827-6388-4C4B-8BD5-6288164DBA47}" type="datetimeFigureOut">
              <a:rPr lang="es-CO" smtClean="0"/>
              <a:t>15/08/2017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F33220-DD61-43B1-8220-FA43930A12B3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9091106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O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O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E7827-6388-4C4B-8BD5-6288164DBA47}" type="datetimeFigureOut">
              <a:rPr lang="es-CO" smtClean="0"/>
              <a:t>15/08/2017</a:t>
            </a:fld>
            <a:endParaRPr lang="es-CO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F33220-DD61-43B1-8220-FA43930A12B3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20677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O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O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E7827-6388-4C4B-8BD5-6288164DBA47}" type="datetimeFigureOut">
              <a:rPr lang="es-CO" smtClean="0"/>
              <a:t>15/08/2017</a:t>
            </a:fld>
            <a:endParaRPr lang="es-CO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F33220-DD61-43B1-8220-FA43930A12B3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4097331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O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E7827-6388-4C4B-8BD5-6288164DBA47}" type="datetimeFigureOut">
              <a:rPr lang="es-CO" smtClean="0"/>
              <a:t>15/08/2017</a:t>
            </a:fld>
            <a:endParaRPr lang="es-CO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F33220-DD61-43B1-8220-FA43930A12B3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969455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E7827-6388-4C4B-8BD5-6288164DBA47}" type="datetimeFigureOut">
              <a:rPr lang="es-CO" smtClean="0"/>
              <a:t>15/08/2017</a:t>
            </a:fld>
            <a:endParaRPr lang="es-CO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F33220-DD61-43B1-8220-FA43930A12B3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430996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O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E7827-6388-4C4B-8BD5-6288164DBA47}" type="datetimeFigureOut">
              <a:rPr lang="es-CO" smtClean="0"/>
              <a:t>15/08/2017</a:t>
            </a:fld>
            <a:endParaRPr lang="es-CO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F33220-DD61-43B1-8220-FA43930A12B3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052231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CO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s-CO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E7827-6388-4C4B-8BD5-6288164DBA47}" type="datetimeFigureOut">
              <a:rPr lang="es-CO" smtClean="0"/>
              <a:t>15/08/2017</a:t>
            </a:fld>
            <a:endParaRPr lang="es-CO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F33220-DD61-43B1-8220-FA43930A12B3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790718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O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5E7827-6388-4C4B-8BD5-6288164DBA47}" type="datetimeFigureOut">
              <a:rPr lang="es-CO" smtClean="0"/>
              <a:t>15/08/2017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F33220-DD61-43B1-8220-FA43930A12B3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546465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O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301177" y="1708519"/>
            <a:ext cx="10819435" cy="4140000"/>
          </a:xfrm>
          <a:prstGeom prst="rect">
            <a:avLst/>
          </a:prstGeom>
        </p:spPr>
      </p:pic>
      <p:sp>
        <p:nvSpPr>
          <p:cNvPr id="18" name="CuadroTexto 17"/>
          <p:cNvSpPr txBox="1"/>
          <p:nvPr/>
        </p:nvSpPr>
        <p:spPr>
          <a:xfrm>
            <a:off x="1422246" y="390702"/>
            <a:ext cx="5803127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dirty="0"/>
              <a:t>Bioinformatics analysis for G-CSF (CSF3) – Dominant Cluster </a:t>
            </a:r>
          </a:p>
        </p:txBody>
      </p:sp>
      <p:grpSp>
        <p:nvGrpSpPr>
          <p:cNvPr id="19" name="Grupo 18"/>
          <p:cNvGrpSpPr/>
          <p:nvPr/>
        </p:nvGrpSpPr>
        <p:grpSpPr>
          <a:xfrm>
            <a:off x="5527043" y="4928078"/>
            <a:ext cx="2988971" cy="728889"/>
            <a:chOff x="1721224" y="3242483"/>
            <a:chExt cx="2988975" cy="728888"/>
          </a:xfrm>
        </p:grpSpPr>
        <p:cxnSp>
          <p:nvCxnSpPr>
            <p:cNvPr id="8" name="Conector recto 7"/>
            <p:cNvCxnSpPr/>
            <p:nvPr/>
          </p:nvCxnSpPr>
          <p:spPr>
            <a:xfrm flipV="1">
              <a:off x="1721224" y="3462618"/>
              <a:ext cx="228600" cy="4"/>
            </a:xfrm>
            <a:prstGeom prst="line">
              <a:avLst/>
            </a:prstGeom>
            <a:ln w="28575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ector recto 12"/>
            <p:cNvCxnSpPr/>
            <p:nvPr/>
          </p:nvCxnSpPr>
          <p:spPr>
            <a:xfrm flipV="1">
              <a:off x="1721224" y="3641912"/>
              <a:ext cx="228600" cy="4"/>
            </a:xfrm>
            <a:prstGeom prst="line">
              <a:avLst/>
            </a:prstGeom>
            <a:ln w="28575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ector recto 13"/>
            <p:cNvCxnSpPr/>
            <p:nvPr/>
          </p:nvCxnSpPr>
          <p:spPr>
            <a:xfrm flipV="1">
              <a:off x="1721224" y="3843618"/>
              <a:ext cx="228600" cy="4"/>
            </a:xfrm>
            <a:prstGeom prst="line">
              <a:avLst/>
            </a:prstGeom>
            <a:ln w="28575">
              <a:solidFill>
                <a:srgbClr val="DE12C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CuadroTexto 14"/>
            <p:cNvSpPr txBox="1"/>
            <p:nvPr/>
          </p:nvSpPr>
          <p:spPr>
            <a:xfrm>
              <a:off x="1945335" y="3242483"/>
              <a:ext cx="257795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O" sz="1050" dirty="0" err="1"/>
                <a:t>Known</a:t>
              </a:r>
              <a:r>
                <a:rPr lang="es-CO" sz="1050" dirty="0"/>
                <a:t> </a:t>
              </a:r>
              <a:r>
                <a:rPr lang="es-CO" sz="1050" dirty="0" err="1"/>
                <a:t>Interactions</a:t>
              </a:r>
              <a:r>
                <a:rPr lang="es-CO" sz="1050" dirty="0"/>
                <a:t> </a:t>
              </a:r>
              <a:r>
                <a:rPr lang="es-CO" sz="1050" dirty="0" err="1"/>
                <a:t>from</a:t>
              </a:r>
              <a:r>
                <a:rPr lang="es-CO" sz="1050" dirty="0"/>
                <a:t> </a:t>
              </a:r>
              <a:r>
                <a:rPr lang="es-CO" sz="1050" dirty="0" err="1"/>
                <a:t>curated</a:t>
              </a:r>
              <a:r>
                <a:rPr lang="es-CO" sz="1050" dirty="0"/>
                <a:t> </a:t>
              </a:r>
              <a:r>
                <a:rPr lang="es-CO" sz="1050" dirty="0" err="1"/>
                <a:t>databases</a:t>
              </a:r>
              <a:endParaRPr lang="es-CO" sz="1050" dirty="0"/>
            </a:p>
          </p:txBody>
        </p:sp>
        <p:sp>
          <p:nvSpPr>
            <p:cNvPr id="16" name="CuadroTexto 15"/>
            <p:cNvSpPr txBox="1"/>
            <p:nvPr/>
          </p:nvSpPr>
          <p:spPr>
            <a:xfrm>
              <a:off x="1943091" y="3457368"/>
              <a:ext cx="27671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O" sz="1050" dirty="0" err="1"/>
                <a:t>Known</a:t>
              </a:r>
              <a:r>
                <a:rPr lang="es-CO" sz="1050" dirty="0"/>
                <a:t> </a:t>
              </a:r>
              <a:r>
                <a:rPr lang="es-CO" sz="1050" dirty="0" err="1"/>
                <a:t>Interactions</a:t>
              </a:r>
              <a:r>
                <a:rPr lang="es-CO" sz="1050" dirty="0"/>
                <a:t> </a:t>
              </a:r>
              <a:r>
                <a:rPr lang="es-CO" sz="1050" dirty="0" err="1"/>
                <a:t>experimentally</a:t>
              </a:r>
              <a:r>
                <a:rPr lang="es-CO" sz="1050" dirty="0"/>
                <a:t> </a:t>
              </a:r>
              <a:r>
                <a:rPr lang="es-CO" sz="1050" dirty="0" err="1"/>
                <a:t>determined</a:t>
              </a:r>
              <a:endParaRPr lang="es-CO" sz="1050" dirty="0"/>
            </a:p>
          </p:txBody>
        </p:sp>
        <p:sp>
          <p:nvSpPr>
            <p:cNvPr id="17" name="CuadroTexto 16"/>
            <p:cNvSpPr txBox="1"/>
            <p:nvPr/>
          </p:nvSpPr>
          <p:spPr>
            <a:xfrm>
              <a:off x="1959521" y="3717455"/>
              <a:ext cx="223971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O" sz="1050" dirty="0" err="1"/>
                <a:t>Interaction</a:t>
              </a:r>
              <a:r>
                <a:rPr lang="es-CO" sz="1050" dirty="0"/>
                <a:t> </a:t>
              </a:r>
              <a:r>
                <a:rPr lang="es-CO" sz="1050" dirty="0" err="1"/>
                <a:t>determined</a:t>
              </a:r>
              <a:r>
                <a:rPr lang="es-CO" sz="1050" dirty="0"/>
                <a:t> </a:t>
              </a:r>
              <a:r>
                <a:rPr lang="es-CO" sz="1050" dirty="0" err="1"/>
                <a:t>by</a:t>
              </a:r>
              <a:r>
                <a:rPr lang="es-CO" sz="1050" dirty="0"/>
                <a:t> </a:t>
              </a:r>
              <a:r>
                <a:rPr lang="es-CO" sz="1050" dirty="0" err="1"/>
                <a:t>textmining</a:t>
              </a:r>
              <a:endParaRPr lang="es-CO" sz="1050" dirty="0"/>
            </a:p>
          </p:txBody>
        </p:sp>
      </p:grpSp>
    </p:spTree>
    <p:extLst>
      <p:ext uri="{BB962C8B-B14F-4D97-AF65-F5344CB8AC3E}">
        <p14:creationId xmlns:p14="http://schemas.microsoft.com/office/powerpoint/2010/main" val="3324752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Marcador de contenido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590649" y="976170"/>
            <a:ext cx="10236496" cy="4500000"/>
          </a:xfrm>
        </p:spPr>
      </p:pic>
      <p:grpSp>
        <p:nvGrpSpPr>
          <p:cNvPr id="14" name="Grupo 13"/>
          <p:cNvGrpSpPr/>
          <p:nvPr/>
        </p:nvGrpSpPr>
        <p:grpSpPr>
          <a:xfrm>
            <a:off x="5527043" y="4928078"/>
            <a:ext cx="2988971" cy="728889"/>
            <a:chOff x="1721224" y="3242483"/>
            <a:chExt cx="2988975" cy="728888"/>
          </a:xfrm>
        </p:grpSpPr>
        <p:cxnSp>
          <p:nvCxnSpPr>
            <p:cNvPr id="15" name="Conector recto 14"/>
            <p:cNvCxnSpPr/>
            <p:nvPr/>
          </p:nvCxnSpPr>
          <p:spPr>
            <a:xfrm flipV="1">
              <a:off x="1721224" y="3462618"/>
              <a:ext cx="228600" cy="4"/>
            </a:xfrm>
            <a:prstGeom prst="line">
              <a:avLst/>
            </a:prstGeom>
            <a:ln w="28575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ector recto 15"/>
            <p:cNvCxnSpPr/>
            <p:nvPr/>
          </p:nvCxnSpPr>
          <p:spPr>
            <a:xfrm flipV="1">
              <a:off x="1721224" y="3641912"/>
              <a:ext cx="228600" cy="4"/>
            </a:xfrm>
            <a:prstGeom prst="line">
              <a:avLst/>
            </a:prstGeom>
            <a:ln w="28575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ector recto 16"/>
            <p:cNvCxnSpPr/>
            <p:nvPr/>
          </p:nvCxnSpPr>
          <p:spPr>
            <a:xfrm flipV="1">
              <a:off x="1721224" y="3843618"/>
              <a:ext cx="228600" cy="4"/>
            </a:xfrm>
            <a:prstGeom prst="line">
              <a:avLst/>
            </a:prstGeom>
            <a:ln w="28575">
              <a:solidFill>
                <a:srgbClr val="DE12C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CuadroTexto 17"/>
            <p:cNvSpPr txBox="1"/>
            <p:nvPr/>
          </p:nvSpPr>
          <p:spPr>
            <a:xfrm>
              <a:off x="1945335" y="3242483"/>
              <a:ext cx="257795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O" sz="1050" dirty="0" err="1"/>
                <a:t>Known</a:t>
              </a:r>
              <a:r>
                <a:rPr lang="es-CO" sz="1050" dirty="0"/>
                <a:t> </a:t>
              </a:r>
              <a:r>
                <a:rPr lang="es-CO" sz="1050" dirty="0" err="1"/>
                <a:t>Interactions</a:t>
              </a:r>
              <a:r>
                <a:rPr lang="es-CO" sz="1050" dirty="0"/>
                <a:t> </a:t>
              </a:r>
              <a:r>
                <a:rPr lang="es-CO" sz="1050" dirty="0" err="1"/>
                <a:t>from</a:t>
              </a:r>
              <a:r>
                <a:rPr lang="es-CO" sz="1050" dirty="0"/>
                <a:t> </a:t>
              </a:r>
              <a:r>
                <a:rPr lang="es-CO" sz="1050" dirty="0" err="1"/>
                <a:t>curated</a:t>
              </a:r>
              <a:r>
                <a:rPr lang="es-CO" sz="1050" dirty="0"/>
                <a:t> </a:t>
              </a:r>
              <a:r>
                <a:rPr lang="es-CO" sz="1050" dirty="0" err="1"/>
                <a:t>databases</a:t>
              </a:r>
              <a:endParaRPr lang="es-CO" sz="1050" dirty="0"/>
            </a:p>
          </p:txBody>
        </p:sp>
        <p:sp>
          <p:nvSpPr>
            <p:cNvPr id="19" name="CuadroTexto 18"/>
            <p:cNvSpPr txBox="1"/>
            <p:nvPr/>
          </p:nvSpPr>
          <p:spPr>
            <a:xfrm>
              <a:off x="1943091" y="3457368"/>
              <a:ext cx="27671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O" sz="1050" dirty="0" err="1"/>
                <a:t>Known</a:t>
              </a:r>
              <a:r>
                <a:rPr lang="es-CO" sz="1050" dirty="0"/>
                <a:t> </a:t>
              </a:r>
              <a:r>
                <a:rPr lang="es-CO" sz="1050" dirty="0" err="1"/>
                <a:t>Interactions</a:t>
              </a:r>
              <a:r>
                <a:rPr lang="es-CO" sz="1050" dirty="0"/>
                <a:t> </a:t>
              </a:r>
              <a:r>
                <a:rPr lang="es-CO" sz="1050" dirty="0" err="1"/>
                <a:t>experimentally</a:t>
              </a:r>
              <a:r>
                <a:rPr lang="es-CO" sz="1050" dirty="0"/>
                <a:t> </a:t>
              </a:r>
              <a:r>
                <a:rPr lang="es-CO" sz="1050" dirty="0" err="1"/>
                <a:t>determined</a:t>
              </a:r>
              <a:endParaRPr lang="es-CO" sz="1050" dirty="0"/>
            </a:p>
          </p:txBody>
        </p:sp>
        <p:sp>
          <p:nvSpPr>
            <p:cNvPr id="20" name="CuadroTexto 19"/>
            <p:cNvSpPr txBox="1"/>
            <p:nvPr/>
          </p:nvSpPr>
          <p:spPr>
            <a:xfrm>
              <a:off x="1959521" y="3717455"/>
              <a:ext cx="223971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O" sz="1050" dirty="0" err="1"/>
                <a:t>Interaction</a:t>
              </a:r>
              <a:r>
                <a:rPr lang="es-CO" sz="1050" dirty="0"/>
                <a:t> </a:t>
              </a:r>
              <a:r>
                <a:rPr lang="es-CO" sz="1050" dirty="0" err="1"/>
                <a:t>determined</a:t>
              </a:r>
              <a:r>
                <a:rPr lang="es-CO" sz="1050" dirty="0"/>
                <a:t> </a:t>
              </a:r>
              <a:r>
                <a:rPr lang="es-CO" sz="1050" dirty="0" err="1"/>
                <a:t>by</a:t>
              </a:r>
              <a:r>
                <a:rPr lang="es-CO" sz="1050" dirty="0"/>
                <a:t> </a:t>
              </a:r>
              <a:r>
                <a:rPr lang="es-CO" sz="1050" dirty="0" err="1"/>
                <a:t>textmining</a:t>
              </a:r>
              <a:endParaRPr lang="es-CO" sz="1050" dirty="0"/>
            </a:p>
          </p:txBody>
        </p:sp>
      </p:grpSp>
      <p:sp>
        <p:nvSpPr>
          <p:cNvPr id="21" name="CuadroTexto 20"/>
          <p:cNvSpPr txBox="1"/>
          <p:nvPr/>
        </p:nvSpPr>
        <p:spPr>
          <a:xfrm>
            <a:off x="1422246" y="390702"/>
            <a:ext cx="5761705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dirty="0"/>
              <a:t>Bioinformatics analysis for </a:t>
            </a:r>
            <a:r>
              <a:rPr lang="en-US" sz="1801" dirty="0" smtClean="0"/>
              <a:t> </a:t>
            </a:r>
            <a:r>
              <a:rPr lang="en-US" sz="1801" dirty="0" err="1" smtClean="0"/>
              <a:t>IFN</a:t>
            </a:r>
            <a:r>
              <a:rPr lang="en-US" sz="1801" dirty="0" err="1" smtClean="0">
                <a:latin typeface="Symbol" panose="05050102010706020507" pitchFamily="18" charset="2"/>
              </a:rPr>
              <a:t>a</a:t>
            </a:r>
            <a:r>
              <a:rPr lang="en-US" sz="1801" dirty="0" smtClean="0"/>
              <a:t>/Pro-inflammatory </a:t>
            </a:r>
            <a:r>
              <a:rPr lang="en-US" sz="1801" dirty="0"/>
              <a:t>c</a:t>
            </a:r>
            <a:r>
              <a:rPr lang="en-US" sz="1801" dirty="0" smtClean="0"/>
              <a:t>luster </a:t>
            </a:r>
            <a:endParaRPr lang="en-US" sz="1801" dirty="0"/>
          </a:p>
        </p:txBody>
      </p:sp>
    </p:spTree>
    <p:extLst>
      <p:ext uri="{BB962C8B-B14F-4D97-AF65-F5344CB8AC3E}">
        <p14:creationId xmlns:p14="http://schemas.microsoft.com/office/powerpoint/2010/main" val="36487198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</TotalTime>
  <Words>41</Words>
  <Application>Microsoft Office PowerPoint</Application>
  <PresentationFormat>Panorámica</PresentationFormat>
  <Paragraphs>8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Yovana Maria Pacheco Nieva</dc:creator>
  <cp:lastModifiedBy>Julian Esteban Barahona Correa</cp:lastModifiedBy>
  <cp:revision>5</cp:revision>
  <dcterms:created xsi:type="dcterms:W3CDTF">2017-08-15T20:00:34Z</dcterms:created>
  <dcterms:modified xsi:type="dcterms:W3CDTF">2017-08-15T21:43:29Z</dcterms:modified>
</cp:coreProperties>
</file>